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3396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977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044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018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378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923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643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051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24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73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457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216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922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8597" y="7995875"/>
            <a:ext cx="1455366" cy="10543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9932" y="6173609"/>
            <a:ext cx="1454619" cy="10485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3041" y="4322720"/>
            <a:ext cx="1439157" cy="1037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4296" y="4319290"/>
            <a:ext cx="1422554" cy="10326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0234" y="2415357"/>
            <a:ext cx="1474272" cy="10626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3443" y="2431948"/>
            <a:ext cx="1442093" cy="10374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5672" y="524857"/>
            <a:ext cx="1495990" cy="10859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" name="テキスト ボックス 71"/>
          <p:cNvSpPr txBox="1"/>
          <p:nvPr/>
        </p:nvSpPr>
        <p:spPr>
          <a:xfrm>
            <a:off x="1171222" y="5914231"/>
            <a:ext cx="25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 abnorm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lesterol levels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3317148" y="6594746"/>
            <a:ext cx="1121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 rot="16200000">
            <a:off x="445708" y="6600114"/>
            <a:ext cx="1111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4794790" y="7343771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1911244" y="7323050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r>
              <a:rPr lang="en-US" altLang="ja-JP" sz="1400" dirty="0" smtClean="0"/>
              <a:t> </a:t>
            </a: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5681101" y="6136993"/>
            <a:ext cx="1246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00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9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2800206" y="6138769"/>
            <a:ext cx="7667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32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00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 rot="16200000">
            <a:off x="3314196" y="963936"/>
            <a:ext cx="1125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4794083" y="1710774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5682075" y="493198"/>
            <a:ext cx="8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23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0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4752877" y="332579"/>
            <a:ext cx="1207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me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4095621" y="5909673"/>
            <a:ext cx="2277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norm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lesterol levels</a:t>
            </a: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723115" y="200340"/>
            <a:ext cx="476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722572" y="5772358"/>
            <a:ext cx="520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1927732" y="3579745"/>
            <a:ext cx="698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4803666" y="3574770"/>
            <a:ext cx="800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 rot="16200000">
            <a:off x="3215534" y="2724072"/>
            <a:ext cx="1333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 rot="16200000">
            <a:off x="418981" y="2801185"/>
            <a:ext cx="1188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1866686" y="2165538"/>
            <a:ext cx="871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70</a:t>
            </a:r>
            <a:endParaRPr kumimoji="1"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2813497" y="2364216"/>
            <a:ext cx="7665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26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00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5680098" y="2366505"/>
            <a:ext cx="895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kumimoji="1"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9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711945" y="2060575"/>
            <a:ext cx="629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 rot="16200000">
            <a:off x="455031" y="960713"/>
            <a:ext cx="1122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913417" y="1711164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2794630" y="493188"/>
            <a:ext cx="8813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= -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21</a:t>
            </a:r>
            <a:endParaRPr lang="en-US" altLang="ja-JP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19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953510" y="336150"/>
            <a:ext cx="6574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正方形/長方形 53"/>
          <p:cNvSpPr/>
          <p:nvPr/>
        </p:nvSpPr>
        <p:spPr>
          <a:xfrm>
            <a:off x="2800807" y="4240009"/>
            <a:ext cx="9309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= -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27</a:t>
            </a:r>
            <a:endParaRPr lang="en-US" altLang="ja-JP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09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1825064" y="4006705"/>
            <a:ext cx="85863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BP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681325" y="4008291"/>
            <a:ext cx="1191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P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kumimoji="1"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2062688" y="5513071"/>
            <a:ext cx="838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793506" y="5470966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 rot="16200000">
            <a:off x="3238612" y="4655174"/>
            <a:ext cx="1285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 rot="16200000">
            <a:off x="372686" y="4653927"/>
            <a:ext cx="1285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720103" y="3860132"/>
            <a:ext cx="739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4875072" y="9202735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20" name="テキスト ボックス 119"/>
          <p:cNvSpPr txBox="1"/>
          <p:nvPr/>
        </p:nvSpPr>
        <p:spPr>
          <a:xfrm rot="16200000">
            <a:off x="363398" y="8328662"/>
            <a:ext cx="1277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259219" y="7765115"/>
            <a:ext cx="273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 diabetes mellitu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2794629" y="8023328"/>
            <a:ext cx="1246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18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03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1956749" y="9195465"/>
            <a:ext cx="605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4208635" y="7772806"/>
            <a:ext cx="2065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diabete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litu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5682075" y="8009698"/>
            <a:ext cx="1246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09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5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727760" y="7645630"/>
            <a:ext cx="441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 rot="16200000">
            <a:off x="3301223" y="8398845"/>
            <a:ext cx="1161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525003" y="534245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1881022" y="5334563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2288741" y="5343215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2628411" y="5343215"/>
            <a:ext cx="370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125674" y="4260544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201304" y="4643598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1081973" y="5026545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391530" y="531921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4773675" y="5319218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5155268" y="5319973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4018327" y="4237302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4093957" y="4620356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3974626" y="500330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5484598" y="5309640"/>
            <a:ext cx="955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正方形/長方形 54"/>
          <p:cNvSpPr/>
          <p:nvPr/>
        </p:nvSpPr>
        <p:spPr>
          <a:xfrm>
            <a:off x="5682723" y="4237463"/>
            <a:ext cx="8033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ja-JP" alt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  <a:endParaRPr lang="en-US" altLang="ja-JP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ja-JP" alt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96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2639082" y="3413805"/>
            <a:ext cx="493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1520451" y="341728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1902596" y="3417287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2284189" y="3418042"/>
            <a:ext cx="366129" cy="2837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1134185" y="2322308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1209815" y="2705362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1090484" y="3088309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712897" y="2216506"/>
            <a:ext cx="904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1511563" y="901285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1893708" y="901285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284826" y="9013610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1125297" y="7930939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1200927" y="831399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1081596" y="8696940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2640152" y="8990833"/>
            <a:ext cx="39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4414151" y="9048275"/>
            <a:ext cx="432048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4796296" y="9048276"/>
            <a:ext cx="648072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5187414" y="9049031"/>
            <a:ext cx="71065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4064098" y="7966360"/>
            <a:ext cx="5951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4116578" y="8349414"/>
            <a:ext cx="5951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3997247" y="8732361"/>
            <a:ext cx="595145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5526269" y="9038698"/>
            <a:ext cx="371796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1488413" y="719502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1870558" y="7195029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2261676" y="7195784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1128273" y="611311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1203903" y="6496167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1084572" y="6879114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2600531" y="7185451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4379839" y="720749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4761984" y="720749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5153102" y="7208250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4006636" y="6125579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4082266" y="650863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3962935" y="6891580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5491957" y="7197917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4375682" y="1563013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4757827" y="156301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5148945" y="1563769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4002479" y="481098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4078109" y="864152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3958778" y="1247099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5487800" y="1553436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1513063" y="156587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1895208" y="1565873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2286326" y="1566628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1126797" y="483957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1202427" y="867011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1083096" y="1249958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2625181" y="1556295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4369791" y="344170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4751936" y="3441709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5143054" y="3429401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3996588" y="235979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4072218" y="2742847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3952887" y="3125794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5481909" y="3432131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2749" y="581247"/>
            <a:ext cx="1424811" cy="10270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4545" y="6214109"/>
            <a:ext cx="1390884" cy="10057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7737" y="8058054"/>
            <a:ext cx="1405896" cy="10153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38724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</TotalTime>
  <Words>202</Words>
  <Application>Microsoft Office PowerPoint</Application>
  <PresentationFormat>A4 210 x 297 mm</PresentationFormat>
  <Paragraphs>12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山口 晃典</dc:creator>
  <cp:lastModifiedBy>血液浄化療法部</cp:lastModifiedBy>
  <cp:revision>9</cp:revision>
  <dcterms:created xsi:type="dcterms:W3CDTF">2016-06-03T07:07:30Z</dcterms:created>
  <dcterms:modified xsi:type="dcterms:W3CDTF">2017-03-24T12:15:31Z</dcterms:modified>
</cp:coreProperties>
</file>